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86" r:id="rId2"/>
    <p:sldId id="294" r:id="rId3"/>
    <p:sldId id="278" r:id="rId4"/>
    <p:sldId id="296" r:id="rId5"/>
    <p:sldId id="297" r:id="rId6"/>
    <p:sldId id="298" r:id="rId7"/>
    <p:sldId id="299" r:id="rId8"/>
  </p:sldIdLst>
  <p:sldSz cx="12192000" cy="6858000"/>
  <p:notesSz cx="6858000" cy="9144000"/>
  <p:custDataLst>
    <p:tags r:id="rId9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F00"/>
    <a:srgbClr val="3333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233" autoAdjust="0"/>
    <p:restoredTop sz="94660"/>
  </p:normalViewPr>
  <p:slideViewPr>
    <p:cSldViewPr snapToGrid="0">
      <p:cViewPr varScale="1">
        <p:scale>
          <a:sx n="86" d="100"/>
          <a:sy n="86" d="100"/>
        </p:scale>
        <p:origin x="734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tags" Target="tags/tag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0C598-D0E2-4DA3-830D-9D2C955FDA10}" type="datetimeFigureOut">
              <a:rPr lang="zh-CN" altLang="en-US" smtClean="0"/>
              <a:t>2022/1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7E69B-BAE8-4461-8BCA-38C6B3F82EE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0C598-D0E2-4DA3-830D-9D2C955FDA10}" type="datetimeFigureOut">
              <a:rPr lang="zh-CN" altLang="en-US" smtClean="0"/>
              <a:t>2022/1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7E69B-BAE8-4461-8BCA-38C6B3F82EE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0C598-D0E2-4DA3-830D-9D2C955FDA10}" type="datetimeFigureOut">
              <a:rPr lang="zh-CN" altLang="en-US" smtClean="0"/>
              <a:t>2022/1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7E69B-BAE8-4461-8BCA-38C6B3F82EE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0C598-D0E2-4DA3-830D-9D2C955FDA10}" type="datetimeFigureOut">
              <a:rPr lang="zh-CN" altLang="en-US" smtClean="0"/>
              <a:t>2022/1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7E69B-BAE8-4461-8BCA-38C6B3F82EE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0C598-D0E2-4DA3-830D-9D2C955FDA10}" type="datetimeFigureOut">
              <a:rPr lang="zh-CN" altLang="en-US" smtClean="0"/>
              <a:t>2022/1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7E69B-BAE8-4461-8BCA-38C6B3F82EE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0C598-D0E2-4DA3-830D-9D2C955FDA10}" type="datetimeFigureOut">
              <a:rPr lang="zh-CN" altLang="en-US" smtClean="0"/>
              <a:t>2022/11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7E69B-BAE8-4461-8BCA-38C6B3F82EE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0C598-D0E2-4DA3-830D-9D2C955FDA10}" type="datetimeFigureOut">
              <a:rPr lang="zh-CN" altLang="en-US" smtClean="0"/>
              <a:t>2022/11/1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7E69B-BAE8-4461-8BCA-38C6B3F82EE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0C598-D0E2-4DA3-830D-9D2C955FDA10}" type="datetimeFigureOut">
              <a:rPr lang="zh-CN" altLang="en-US" smtClean="0"/>
              <a:t>2022/11/1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7E69B-BAE8-4461-8BCA-38C6B3F82EE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0C598-D0E2-4DA3-830D-9D2C955FDA10}" type="datetimeFigureOut">
              <a:rPr lang="zh-CN" altLang="en-US" smtClean="0"/>
              <a:t>2022/11/1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7E69B-BAE8-4461-8BCA-38C6B3F82EE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0C598-D0E2-4DA3-830D-9D2C955FDA10}" type="datetimeFigureOut">
              <a:rPr lang="zh-CN" altLang="en-US" smtClean="0"/>
              <a:t>2022/11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7E69B-BAE8-4461-8BCA-38C6B3F82EE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0C598-D0E2-4DA3-830D-9D2C955FDA10}" type="datetimeFigureOut">
              <a:rPr lang="zh-CN" altLang="en-US" smtClean="0"/>
              <a:t>2022/11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7E69B-BAE8-4461-8BCA-38C6B3F82EE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E0C598-D0E2-4DA3-830D-9D2C955FDA10}" type="datetimeFigureOut">
              <a:rPr lang="zh-CN" altLang="en-US" smtClean="0"/>
              <a:t>2022/1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B7E69B-BAE8-4461-8BCA-38C6B3F82EE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2785929" y="1060697"/>
            <a:ext cx="6004489" cy="4154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AU" altLang="zh-CN" sz="105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Table S1</a:t>
            </a:r>
            <a:r>
              <a:rPr kumimoji="0" lang="en-AU" altLang="zh-CN" sz="105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AU" altLang="zh-CN" sz="1050" dirty="0"/>
              <a:t>Oligonucleotide primers used to amplify and sequence the PyRV1 genome</a:t>
            </a:r>
            <a:endParaRPr kumimoji="0" lang="en-AU" altLang="zh-CN" sz="105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</a:pPr>
            <a:endParaRPr kumimoji="0" lang="en-AU" altLang="zh-CN" sz="105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aphicFrame>
        <p:nvGraphicFramePr>
          <p:cNvPr id="2" name="表格 1"/>
          <p:cNvGraphicFramePr>
            <a:graphicFrameLocks noGrp="1"/>
          </p:cNvGraphicFramePr>
          <p:nvPr/>
        </p:nvGraphicFramePr>
        <p:xfrm>
          <a:off x="2961017" y="1476196"/>
          <a:ext cx="6302623" cy="435133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85544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03726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40991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26590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</a:rPr>
                        <a:t>Primer </a:t>
                      </a:r>
                      <a:endParaRPr lang="zh-CN" sz="10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Primer sequence(5’-3)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 err="1">
                          <a:effectLst/>
                        </a:rPr>
                        <a:t>Amplicon</a:t>
                      </a:r>
                      <a:r>
                        <a:rPr lang="en-US" sz="1000" kern="100" dirty="0">
                          <a:effectLst/>
                        </a:rPr>
                        <a:t> No. in Fig.2 and Fig. S1</a:t>
                      </a:r>
                      <a:endParaRPr lang="zh-CN" sz="10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26590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Rhab For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GGATMTGGGGBCATCC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(</a:t>
                      </a:r>
                      <a:r>
                        <a:rPr lang="en-US" altLang="zh-CN" sz="1000" kern="1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Lamprecht</a:t>
                      </a:r>
                      <a:r>
                        <a:rPr lang="en-US" altLang="zh-CN" sz="1000" kern="1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et al. 2009</a:t>
                      </a:r>
                      <a:r>
                        <a:rPr lang="en-US" sz="1000" kern="1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)</a:t>
                      </a:r>
                      <a:endParaRPr lang="zh-CN" sz="1000" kern="1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2269" marR="62269" marT="8648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26590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Rhab Rev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</a:rPr>
                        <a:t>GTCCABCCYTTTTGYC</a:t>
                      </a:r>
                      <a:endParaRPr lang="zh-CN" sz="10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26590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</a:rPr>
                        <a:t>5540F</a:t>
                      </a:r>
                      <a:endParaRPr lang="zh-CN" sz="10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TATTGCTCCC ACACCCAGT CAAC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</a:rPr>
                        <a:t>2 </a:t>
                      </a:r>
                      <a:endParaRPr lang="zh-CN" sz="10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26590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6580R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GTTGATCCATGCAGGTTTGTCGTAT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26590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260F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CCAGAGAATCCATCAGGTCAATGTCC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3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26590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1897R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CCTGATAATTGCTTGTGAGT ACTTCCGA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26590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1838F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</a:rPr>
                        <a:t>GCAGGACTACCAACCTCGGTGTTG</a:t>
                      </a:r>
                      <a:endParaRPr lang="zh-CN" sz="10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4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26590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3292R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GATCTGATGGACCTCTGACA TCCTG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26590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3178F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TGGTGCCCTTCTATAGAACCCACATCC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5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26590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4537R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TGCGTGTAAATGGTAACACCCTTCCTC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72715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4448F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CCAGCTATACTCTTCCATTCGGGAC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6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26590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5734R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CCTGCTCTCCTGTATACCTGATAGTC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26590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6432F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GTGTGCAACACAGATCAATCCCAA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7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26590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8353R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TGCTTCCATCTTTCTCATGC CTCCC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26590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9007F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TACTTCCCAATGATAACAATGTCGGA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8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26590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11103R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AGTTAGTGGGGATCCCTCCGTGTT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26590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11039F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</a:rPr>
                        <a:t>CAGGTGATGTTGAACACAGATATCACGA</a:t>
                      </a:r>
                      <a:endParaRPr lang="zh-CN" sz="100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</a:rPr>
                        <a:t>9</a:t>
                      </a:r>
                      <a:endParaRPr lang="zh-CN" sz="10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26590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</a:rPr>
                        <a:t>13265R</a:t>
                      </a:r>
                      <a:endParaRPr lang="zh-CN" sz="10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</a:rPr>
                        <a:t>CTTTGATCAGCAAGATTTGTCTCCAG</a:t>
                      </a:r>
                      <a:endParaRPr lang="zh-CN" sz="100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Vrinda" panose="020B0502040204020203" pitchFamily="34" charset="0"/>
                      </a:endParaRPr>
                    </a:p>
                  </a:txBody>
                  <a:tcPr marL="62269" marR="62269" marT="8648" marB="0" anchor="ctr"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文本框 10"/>
          <p:cNvSpPr txBox="1"/>
          <p:nvPr/>
        </p:nvSpPr>
        <p:spPr>
          <a:xfrm>
            <a:off x="1389970" y="832809"/>
            <a:ext cx="1008404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0bp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1389970" y="1296167"/>
            <a:ext cx="10084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0bp</a:t>
            </a:r>
          </a:p>
        </p:txBody>
      </p:sp>
      <p:cxnSp>
        <p:nvCxnSpPr>
          <p:cNvPr id="13" name="直接连接符 12"/>
          <p:cNvCxnSpPr/>
          <p:nvPr/>
        </p:nvCxnSpPr>
        <p:spPr>
          <a:xfrm>
            <a:off x="2280574" y="1064719"/>
            <a:ext cx="27346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连接符 13"/>
          <p:cNvCxnSpPr/>
          <p:nvPr/>
        </p:nvCxnSpPr>
        <p:spPr>
          <a:xfrm>
            <a:off x="2288756" y="1480833"/>
            <a:ext cx="27346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文本框 15"/>
          <p:cNvSpPr txBox="1"/>
          <p:nvPr/>
        </p:nvSpPr>
        <p:spPr>
          <a:xfrm>
            <a:off x="2729671" y="308763"/>
            <a:ext cx="25593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dist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12345</a:t>
            </a:r>
          </a:p>
        </p:txBody>
      </p:sp>
      <p:pic>
        <p:nvPicPr>
          <p:cNvPr id="17" name="图片 16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6044" r="15526" b="48037"/>
          <a:stretch>
            <a:fillRect/>
          </a:stretch>
        </p:blipFill>
        <p:spPr>
          <a:xfrm>
            <a:off x="2532904" y="723590"/>
            <a:ext cx="2756150" cy="993949"/>
          </a:xfrm>
          <a:prstGeom prst="rect">
            <a:avLst/>
          </a:prstGeom>
        </p:spPr>
      </p:pic>
      <p:cxnSp>
        <p:nvCxnSpPr>
          <p:cNvPr id="18" name="直接连接符 17"/>
          <p:cNvCxnSpPr/>
          <p:nvPr/>
        </p:nvCxnSpPr>
        <p:spPr>
          <a:xfrm flipV="1">
            <a:off x="3351476" y="1171262"/>
            <a:ext cx="204401" cy="160802"/>
          </a:xfrm>
          <a:prstGeom prst="line">
            <a:avLst/>
          </a:prstGeom>
          <a:ln w="28575">
            <a:solidFill>
              <a:srgbClr val="00FF00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本框 20"/>
          <p:cNvSpPr txBox="1"/>
          <p:nvPr/>
        </p:nvSpPr>
        <p:spPr>
          <a:xfrm>
            <a:off x="5730282" y="737566"/>
            <a:ext cx="10340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0bp</a:t>
            </a:r>
          </a:p>
        </p:txBody>
      </p:sp>
      <p:sp>
        <p:nvSpPr>
          <p:cNvPr id="22" name="文本框 21"/>
          <p:cNvSpPr txBox="1"/>
          <p:nvPr/>
        </p:nvSpPr>
        <p:spPr>
          <a:xfrm>
            <a:off x="5730282" y="1204956"/>
            <a:ext cx="10254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0bp</a:t>
            </a:r>
          </a:p>
        </p:txBody>
      </p:sp>
      <p:cxnSp>
        <p:nvCxnSpPr>
          <p:cNvPr id="23" name="直接连接符 22"/>
          <p:cNvCxnSpPr/>
          <p:nvPr/>
        </p:nvCxnSpPr>
        <p:spPr>
          <a:xfrm>
            <a:off x="6669956" y="922232"/>
            <a:ext cx="27346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连接符 23"/>
          <p:cNvCxnSpPr/>
          <p:nvPr/>
        </p:nvCxnSpPr>
        <p:spPr>
          <a:xfrm>
            <a:off x="6669957" y="1410283"/>
            <a:ext cx="27346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文本框 24"/>
          <p:cNvSpPr txBox="1"/>
          <p:nvPr/>
        </p:nvSpPr>
        <p:spPr>
          <a:xfrm>
            <a:off x="6943422" y="401208"/>
            <a:ext cx="1897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dist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123</a:t>
            </a:r>
          </a:p>
        </p:txBody>
      </p:sp>
      <p:pic>
        <p:nvPicPr>
          <p:cNvPr id="26" name="图片 25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661" t="43096" r="43676" b="45933"/>
          <a:stretch>
            <a:fillRect/>
          </a:stretch>
        </p:blipFill>
        <p:spPr>
          <a:xfrm>
            <a:off x="6825347" y="754688"/>
            <a:ext cx="2133677" cy="993949"/>
          </a:xfrm>
          <a:prstGeom prst="rect">
            <a:avLst/>
          </a:prstGeom>
        </p:spPr>
      </p:pic>
      <p:grpSp>
        <p:nvGrpSpPr>
          <p:cNvPr id="27" name="组合 26"/>
          <p:cNvGrpSpPr/>
          <p:nvPr/>
        </p:nvGrpSpPr>
        <p:grpSpPr>
          <a:xfrm>
            <a:off x="1722353" y="2472871"/>
            <a:ext cx="2706894" cy="1235602"/>
            <a:chOff x="3596358" y="1064346"/>
            <a:chExt cx="2706894" cy="1235602"/>
          </a:xfrm>
        </p:grpSpPr>
        <p:grpSp>
          <p:nvGrpSpPr>
            <p:cNvPr id="28" name="组合 27"/>
            <p:cNvGrpSpPr/>
            <p:nvPr/>
          </p:nvGrpSpPr>
          <p:grpSpPr>
            <a:xfrm>
              <a:off x="3596358" y="1433678"/>
              <a:ext cx="2706894" cy="866270"/>
              <a:chOff x="3596358" y="1433678"/>
              <a:chExt cx="2706894" cy="866270"/>
            </a:xfrm>
          </p:grpSpPr>
          <p:pic>
            <p:nvPicPr>
              <p:cNvPr id="30" name="图片 29"/>
              <p:cNvPicPr/>
              <p:nvPr/>
            </p:nvPicPr>
            <p:blipFill rotWithShape="1">
              <a:blip r:embed="rId4"/>
              <a:srcRect l="77785" t="39529" r="1204" b="5330"/>
              <a:stretch>
                <a:fillRect/>
              </a:stretch>
            </p:blipFill>
            <p:spPr>
              <a:xfrm>
                <a:off x="5230028" y="1433678"/>
                <a:ext cx="1073224" cy="866270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31" name="图片 30"/>
              <p:cNvPicPr/>
              <p:nvPr/>
            </p:nvPicPr>
            <p:blipFill rotWithShape="1">
              <a:blip r:embed="rId4"/>
              <a:srcRect l="155" t="39529" r="67862" b="5330"/>
              <a:stretch>
                <a:fillRect/>
              </a:stretch>
            </p:blipFill>
            <p:spPr>
              <a:xfrm>
                <a:off x="3596358" y="1433678"/>
                <a:ext cx="1633670" cy="866270"/>
              </a:xfrm>
              <a:prstGeom prst="rect">
                <a:avLst/>
              </a:prstGeom>
              <a:noFill/>
              <a:ln>
                <a:noFill/>
              </a:ln>
            </p:spPr>
          </p:pic>
        </p:grpSp>
        <p:sp>
          <p:nvSpPr>
            <p:cNvPr id="29" name="文本框 28"/>
            <p:cNvSpPr txBox="1"/>
            <p:nvPr/>
          </p:nvSpPr>
          <p:spPr>
            <a:xfrm>
              <a:off x="4503635" y="1064346"/>
              <a:ext cx="145278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dist"/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1</a:t>
              </a:r>
            </a:p>
          </p:txBody>
        </p:sp>
      </p:grpSp>
      <p:grpSp>
        <p:nvGrpSpPr>
          <p:cNvPr id="39" name="组合 38"/>
          <p:cNvGrpSpPr/>
          <p:nvPr/>
        </p:nvGrpSpPr>
        <p:grpSpPr>
          <a:xfrm>
            <a:off x="5847993" y="2472871"/>
            <a:ext cx="2883910" cy="1346002"/>
            <a:chOff x="5262777" y="2811199"/>
            <a:chExt cx="2883910" cy="1346002"/>
          </a:xfrm>
        </p:grpSpPr>
        <p:pic>
          <p:nvPicPr>
            <p:cNvPr id="32" name="图片 31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0391" r="59642" b="16087"/>
            <a:stretch>
              <a:fillRect/>
            </a:stretch>
          </p:blipFill>
          <p:spPr>
            <a:xfrm>
              <a:off x="6358206" y="3180531"/>
              <a:ext cx="1788481" cy="976670"/>
            </a:xfrm>
            <a:prstGeom prst="rect">
              <a:avLst/>
            </a:prstGeom>
          </p:spPr>
        </p:pic>
        <p:cxnSp>
          <p:nvCxnSpPr>
            <p:cNvPr id="33" name="直接连接符 32"/>
            <p:cNvCxnSpPr/>
            <p:nvPr/>
          </p:nvCxnSpPr>
          <p:spPr>
            <a:xfrm flipV="1">
              <a:off x="7848432" y="3452864"/>
              <a:ext cx="204401" cy="160802"/>
            </a:xfrm>
            <a:prstGeom prst="line">
              <a:avLst/>
            </a:prstGeom>
            <a:ln w="28575">
              <a:solidFill>
                <a:srgbClr val="00FF00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文本框 33"/>
            <p:cNvSpPr txBox="1"/>
            <p:nvPr/>
          </p:nvSpPr>
          <p:spPr>
            <a:xfrm>
              <a:off x="5262777" y="3418537"/>
              <a:ext cx="9400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50bp</a:t>
              </a:r>
            </a:p>
          </p:txBody>
        </p:sp>
        <p:sp>
          <p:nvSpPr>
            <p:cNvPr id="35" name="文本框 34"/>
            <p:cNvSpPr txBox="1"/>
            <p:nvPr/>
          </p:nvSpPr>
          <p:spPr>
            <a:xfrm>
              <a:off x="5271323" y="3787869"/>
              <a:ext cx="93149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0bp</a:t>
              </a:r>
            </a:p>
          </p:txBody>
        </p:sp>
        <p:cxnSp>
          <p:nvCxnSpPr>
            <p:cNvPr id="36" name="直接连接符 35"/>
            <p:cNvCxnSpPr/>
            <p:nvPr/>
          </p:nvCxnSpPr>
          <p:spPr>
            <a:xfrm>
              <a:off x="6108449" y="3646855"/>
              <a:ext cx="360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接连接符 36"/>
            <p:cNvCxnSpPr/>
            <p:nvPr/>
          </p:nvCxnSpPr>
          <p:spPr>
            <a:xfrm>
              <a:off x="6108449" y="3972535"/>
              <a:ext cx="396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文本框 37"/>
            <p:cNvSpPr txBox="1"/>
            <p:nvPr/>
          </p:nvSpPr>
          <p:spPr>
            <a:xfrm>
              <a:off x="6565864" y="2811199"/>
              <a:ext cx="148696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dist"/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 1 2</a:t>
              </a:r>
            </a:p>
          </p:txBody>
        </p:sp>
      </p:grpSp>
      <p:sp>
        <p:nvSpPr>
          <p:cNvPr id="40" name="矩形 39"/>
          <p:cNvSpPr/>
          <p:nvPr/>
        </p:nvSpPr>
        <p:spPr>
          <a:xfrm>
            <a:off x="294132" y="3980806"/>
            <a:ext cx="11830812" cy="25844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Fig.S1. RT-PCR amplification Results.</a:t>
            </a:r>
            <a:endParaRPr lang="zh-CN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.DL2000DNA Marker.</a:t>
            </a:r>
            <a:endParaRPr lang="zh-CN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RT-PCR detection for PyRV1-inoculated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.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utinosa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mplicon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 with primer pair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hab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/Rev. 1.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mplicon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om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.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utinosa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-3.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mplicon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 from PyRV1-infected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is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lyphylla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r.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unnanensis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4. Healthy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.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utinosa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5.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lthy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.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lyphylla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r.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unnanensis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RT-PCR detection for PyRV1-inoculated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.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nthamiana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primer pair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hab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/Rev.1.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mplicon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om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.benthamiana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2.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mplicon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 from PyRV1-infected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is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lyphylla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r.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unnanensis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3. Healthy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.benthamiana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RT-PCR amplification for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mplicon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. 1.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mplicon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.</a:t>
            </a:r>
            <a:endParaRPr lang="zh-CN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RACE for 5’ and 3’ end of PyRV1. 1. 5’-RACE. 2. 3’-RACE.</a:t>
            </a:r>
            <a:endParaRPr lang="zh-CN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1405338" y="179837"/>
            <a:ext cx="4971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42" name="文本框 41"/>
          <p:cNvSpPr txBox="1"/>
          <p:nvPr/>
        </p:nvSpPr>
        <p:spPr>
          <a:xfrm>
            <a:off x="5733658" y="64849"/>
            <a:ext cx="4971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1430268" y="2196095"/>
            <a:ext cx="4971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44" name="文本框 43"/>
          <p:cNvSpPr txBox="1"/>
          <p:nvPr/>
        </p:nvSpPr>
        <p:spPr>
          <a:xfrm>
            <a:off x="5845169" y="2142582"/>
            <a:ext cx="4971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960" r="25523" b="16211"/>
          <a:stretch>
            <a:fillRect/>
          </a:stretch>
        </p:blipFill>
        <p:spPr>
          <a:xfrm>
            <a:off x="3400864" y="2026111"/>
            <a:ext cx="3273212" cy="3237959"/>
          </a:xfrm>
          <a:prstGeom prst="rect">
            <a:avLst/>
          </a:prstGeom>
        </p:spPr>
      </p:pic>
      <p:sp>
        <p:nvSpPr>
          <p:cNvPr id="6" name="矩形 5"/>
          <p:cNvSpPr/>
          <p:nvPr/>
        </p:nvSpPr>
        <p:spPr>
          <a:xfrm>
            <a:off x="1384203" y="5469397"/>
            <a:ext cx="8406765" cy="64516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. RT-PCR amplification for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mplicon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-9 of the complete genome of PyRV1</a:t>
            </a:r>
            <a:endParaRPr lang="zh-CN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.DL2000 DNA Marker. 1-7 represents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mplicon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-9 in the complete genome of PyRV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2341547" y="3173127"/>
            <a:ext cx="9400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0bp</a:t>
            </a:r>
          </a:p>
        </p:txBody>
      </p:sp>
      <p:sp>
        <p:nvSpPr>
          <p:cNvPr id="7" name="文本框 6"/>
          <p:cNvSpPr txBox="1"/>
          <p:nvPr/>
        </p:nvSpPr>
        <p:spPr>
          <a:xfrm>
            <a:off x="2341547" y="3640517"/>
            <a:ext cx="9314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0bp</a:t>
            </a:r>
          </a:p>
        </p:txBody>
      </p:sp>
      <p:cxnSp>
        <p:nvCxnSpPr>
          <p:cNvPr id="9" name="直接连接符 8"/>
          <p:cNvCxnSpPr/>
          <p:nvPr/>
        </p:nvCxnSpPr>
        <p:spPr>
          <a:xfrm>
            <a:off x="3187218" y="3357793"/>
            <a:ext cx="27346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连接符 9"/>
          <p:cNvCxnSpPr/>
          <p:nvPr/>
        </p:nvCxnSpPr>
        <p:spPr>
          <a:xfrm>
            <a:off x="3187219" y="3845844"/>
            <a:ext cx="27346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文本框 10"/>
          <p:cNvSpPr txBox="1"/>
          <p:nvPr/>
        </p:nvSpPr>
        <p:spPr>
          <a:xfrm>
            <a:off x="3520867" y="1717705"/>
            <a:ext cx="30337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dist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1234567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2"/>
          <a:srcRect t="1300" r="20098" b="21604"/>
          <a:stretch>
            <a:fillRect/>
          </a:stretch>
        </p:blipFill>
        <p:spPr>
          <a:xfrm>
            <a:off x="330761" y="266217"/>
            <a:ext cx="3988546" cy="6466772"/>
          </a:xfrm>
          <a:prstGeom prst="rect">
            <a:avLst/>
          </a:prstGeom>
        </p:spPr>
      </p:pic>
      <p:cxnSp>
        <p:nvCxnSpPr>
          <p:cNvPr id="4" name="直接连接符 3"/>
          <p:cNvCxnSpPr/>
          <p:nvPr/>
        </p:nvCxnSpPr>
        <p:spPr>
          <a:xfrm>
            <a:off x="4407874" y="344845"/>
            <a:ext cx="0" cy="241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文本框 4"/>
          <p:cNvSpPr txBox="1"/>
          <p:nvPr/>
        </p:nvSpPr>
        <p:spPr>
          <a:xfrm>
            <a:off x="4628831" y="1412604"/>
            <a:ext cx="244409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i="1" dirty="0" err="1"/>
              <a:t>Betanucleorhabdovirus</a:t>
            </a:r>
            <a:endParaRPr lang="zh-CN" altLang="en-US" sz="1100" i="1" dirty="0"/>
          </a:p>
        </p:txBody>
      </p:sp>
      <p:sp>
        <p:nvSpPr>
          <p:cNvPr id="6" name="文本框 5"/>
          <p:cNvSpPr txBox="1"/>
          <p:nvPr/>
        </p:nvSpPr>
        <p:spPr>
          <a:xfrm>
            <a:off x="4628826" y="5894212"/>
            <a:ext cx="244409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i="1" dirty="0" err="1"/>
              <a:t>Dichorhabdovirus</a:t>
            </a:r>
            <a:endParaRPr lang="zh-CN" altLang="en-US" sz="1100" i="1" dirty="0"/>
          </a:p>
        </p:txBody>
      </p:sp>
      <p:cxnSp>
        <p:nvCxnSpPr>
          <p:cNvPr id="7" name="直接连接符 6"/>
          <p:cNvCxnSpPr/>
          <p:nvPr/>
        </p:nvCxnSpPr>
        <p:spPr>
          <a:xfrm>
            <a:off x="4407874" y="4823465"/>
            <a:ext cx="0" cy="61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文本框 7"/>
          <p:cNvSpPr txBox="1"/>
          <p:nvPr/>
        </p:nvSpPr>
        <p:spPr>
          <a:xfrm>
            <a:off x="4628830" y="2881250"/>
            <a:ext cx="244409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i="1" dirty="0" err="1"/>
              <a:t>Gamanucleoorhabdovirus</a:t>
            </a:r>
            <a:endParaRPr lang="zh-CN" altLang="en-US" i="1" dirty="0"/>
          </a:p>
        </p:txBody>
      </p:sp>
      <p:cxnSp>
        <p:nvCxnSpPr>
          <p:cNvPr id="9" name="直接连接符 8"/>
          <p:cNvCxnSpPr/>
          <p:nvPr/>
        </p:nvCxnSpPr>
        <p:spPr>
          <a:xfrm>
            <a:off x="4407874" y="2940055"/>
            <a:ext cx="0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连接符 9"/>
          <p:cNvCxnSpPr/>
          <p:nvPr/>
        </p:nvCxnSpPr>
        <p:spPr>
          <a:xfrm>
            <a:off x="4410000" y="3293915"/>
            <a:ext cx="0" cy="828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接连接符 10"/>
          <p:cNvCxnSpPr/>
          <p:nvPr/>
        </p:nvCxnSpPr>
        <p:spPr>
          <a:xfrm>
            <a:off x="4407874" y="4304952"/>
            <a:ext cx="0" cy="360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/>
          <p:cNvSpPr txBox="1"/>
          <p:nvPr/>
        </p:nvSpPr>
        <p:spPr>
          <a:xfrm>
            <a:off x="4628827" y="3519061"/>
            <a:ext cx="244409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i="1" dirty="0" err="1"/>
              <a:t>Alphanucleorhabdovirus</a:t>
            </a:r>
            <a:endParaRPr lang="zh-CN" altLang="en-US" sz="1100" i="1" dirty="0"/>
          </a:p>
        </p:txBody>
      </p:sp>
      <p:cxnSp>
        <p:nvCxnSpPr>
          <p:cNvPr id="13" name="直接连接符 12"/>
          <p:cNvCxnSpPr/>
          <p:nvPr/>
        </p:nvCxnSpPr>
        <p:spPr>
          <a:xfrm>
            <a:off x="4407874" y="5633832"/>
            <a:ext cx="0" cy="648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/>
        </p:nvSpPr>
        <p:spPr>
          <a:xfrm>
            <a:off x="4628827" y="4998660"/>
            <a:ext cx="244409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i="1" dirty="0" err="1"/>
              <a:t>Cytorhabdovirus</a:t>
            </a:r>
            <a:endParaRPr lang="zh-CN" altLang="en-US" sz="1100" i="1" dirty="0"/>
          </a:p>
        </p:txBody>
      </p:sp>
      <p:sp>
        <p:nvSpPr>
          <p:cNvPr id="15" name="文本框 14"/>
          <p:cNvSpPr txBox="1"/>
          <p:nvPr/>
        </p:nvSpPr>
        <p:spPr>
          <a:xfrm>
            <a:off x="4628828" y="4369975"/>
            <a:ext cx="244409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i="1" dirty="0" err="1"/>
              <a:t>Varicosavirus</a:t>
            </a:r>
            <a:endParaRPr lang="zh-CN" altLang="en-US" sz="1100" i="1" dirty="0"/>
          </a:p>
        </p:txBody>
      </p:sp>
      <p:sp>
        <p:nvSpPr>
          <p:cNvPr id="16" name="矩形 15"/>
          <p:cNvSpPr/>
          <p:nvPr/>
        </p:nvSpPr>
        <p:spPr>
          <a:xfrm>
            <a:off x="6834910" y="1676187"/>
            <a:ext cx="5357090" cy="25844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3. Maximum-likelihood tree based on the complete genomes between Paris </a:t>
            </a:r>
            <a:r>
              <a:rPr lang="en-US" altLang="zh-CN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unnanensis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habdovirus 1 (PyRV1) and selected plant rhabdoviruses. Evolutionary analyses were conducted in MEGA X with 1000 bootstrap replicates. Bar indicates amino acid</a:t>
            </a:r>
          </a:p>
          <a:p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stitutions per site. The percentage of trees in which the associated taxa clustered together is shown next to the branches. The novel </a:t>
            </a:r>
            <a:r>
              <a:rPr lang="en-US" altLang="zh-CN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ucleorhabdovirus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s indicated with red triangle.</a:t>
            </a:r>
            <a:endParaRPr lang="zh-CN" altLang="zh-CN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内容占位符 4"/>
          <p:cNvPicPr>
            <a:picLocks noGrp="1" noChangeAspect="1"/>
          </p:cNvPicPr>
          <p:nvPr>
            <p:ph idx="4294967295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646" t="18843" r="33576" b="47461"/>
          <a:stretch>
            <a:fillRect/>
          </a:stretch>
        </p:blipFill>
        <p:spPr>
          <a:xfrm>
            <a:off x="4368399" y="2136022"/>
            <a:ext cx="3179763" cy="2998788"/>
          </a:xfrm>
        </p:spPr>
      </p:pic>
      <p:sp>
        <p:nvSpPr>
          <p:cNvPr id="6" name="文本框 5"/>
          <p:cNvSpPr txBox="1"/>
          <p:nvPr/>
        </p:nvSpPr>
        <p:spPr>
          <a:xfrm>
            <a:off x="3246711" y="3429000"/>
            <a:ext cx="940038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0bp</a:t>
            </a:r>
          </a:p>
        </p:txBody>
      </p:sp>
      <p:sp>
        <p:nvSpPr>
          <p:cNvPr id="7" name="文本框 6"/>
          <p:cNvSpPr txBox="1"/>
          <p:nvPr/>
        </p:nvSpPr>
        <p:spPr>
          <a:xfrm>
            <a:off x="3246711" y="3813266"/>
            <a:ext cx="9314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0bp</a:t>
            </a:r>
          </a:p>
        </p:txBody>
      </p:sp>
      <p:cxnSp>
        <p:nvCxnSpPr>
          <p:cNvPr id="8" name="直接连接符 7"/>
          <p:cNvCxnSpPr/>
          <p:nvPr/>
        </p:nvCxnSpPr>
        <p:spPr>
          <a:xfrm>
            <a:off x="4092382" y="3613666"/>
            <a:ext cx="27346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>
            <a:off x="4092383" y="4018593"/>
            <a:ext cx="27346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>
            <a:off x="4460759" y="1766690"/>
            <a:ext cx="27713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dist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123456789</a:t>
            </a:r>
          </a:p>
        </p:txBody>
      </p:sp>
      <p:sp>
        <p:nvSpPr>
          <p:cNvPr id="11" name="文本框 10"/>
          <p:cNvSpPr txBox="1"/>
          <p:nvPr/>
        </p:nvSpPr>
        <p:spPr>
          <a:xfrm>
            <a:off x="7113027" y="1766690"/>
            <a:ext cx="554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3796145" y="5588000"/>
            <a:ext cx="6271491" cy="9220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S4 RT-PCR detection of PyRV1-infected field samples of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lyphylla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r.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unnanensis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M. DL2000 Marker. Lanes 1-10 represent field samples with virus-like symptoms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47C106CF-836B-4421-BFDB-F2B2177C5492}"/>
              </a:ext>
            </a:extLst>
          </p:cNvPr>
          <p:cNvGrpSpPr/>
          <p:nvPr/>
        </p:nvGrpSpPr>
        <p:grpSpPr>
          <a:xfrm>
            <a:off x="676910" y="830580"/>
            <a:ext cx="5733415" cy="5511800"/>
            <a:chOff x="1225" y="1308"/>
            <a:chExt cx="9029" cy="8680"/>
          </a:xfrm>
        </p:grpSpPr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93387F80-7A0B-436C-B0FE-36DE3B350FA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32039" t="2737" r="13586" b="9056"/>
            <a:stretch>
              <a:fillRect/>
            </a:stretch>
          </p:blipFill>
          <p:spPr>
            <a:xfrm>
              <a:off x="5825" y="5768"/>
              <a:ext cx="4429" cy="4220"/>
            </a:xfrm>
            <a:prstGeom prst="rect">
              <a:avLst/>
            </a:prstGeom>
          </p:spPr>
        </p:pic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BD8ECF45-D6BD-4724-B50B-A2F819EA852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33796" t="26878" r="18926" b="4216"/>
            <a:stretch>
              <a:fillRect/>
            </a:stretch>
          </p:blipFill>
          <p:spPr>
            <a:xfrm>
              <a:off x="1225" y="1308"/>
              <a:ext cx="4346" cy="4217"/>
            </a:xfrm>
            <a:prstGeom prst="rect">
              <a:avLst/>
            </a:prstGeom>
          </p:spPr>
        </p:pic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9140D33E-CBDE-4352-B6F5-33A5A514B74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29948" r="2285" b="3746"/>
            <a:stretch>
              <a:fillRect/>
            </a:stretch>
          </p:blipFill>
          <p:spPr>
            <a:xfrm>
              <a:off x="5825" y="1308"/>
              <a:ext cx="4412" cy="4172"/>
            </a:xfrm>
            <a:prstGeom prst="rect">
              <a:avLst/>
            </a:prstGeom>
          </p:spPr>
        </p:pic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77661CE6-A96D-4B10-BA0C-AEFB230641F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 l="14974" t="14378" r="27663" b="2964"/>
            <a:stretch>
              <a:fillRect/>
            </a:stretch>
          </p:blipFill>
          <p:spPr>
            <a:xfrm>
              <a:off x="1225" y="5768"/>
              <a:ext cx="4364" cy="4186"/>
            </a:xfrm>
            <a:prstGeom prst="rect">
              <a:avLst/>
            </a:prstGeom>
          </p:spPr>
        </p:pic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9C47BA21-4402-499A-A4DF-8B3E858500B7}"/>
                </a:ext>
              </a:extLst>
            </p:cNvPr>
            <p:cNvSpPr txBox="1"/>
            <p:nvPr/>
          </p:nvSpPr>
          <p:spPr>
            <a:xfrm>
              <a:off x="4933" y="4836"/>
              <a:ext cx="59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>
                  <a:solidFill>
                    <a:schemeClr val="bg1"/>
                  </a:solidFill>
                  <a:latin typeface="Times New Roman" panose="02020603050405020304" charset="0"/>
                  <a:cs typeface="Times New Roman" panose="02020603050405020304" charset="0"/>
                </a:rPr>
                <a:t>A</a:t>
              </a: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9959CEA4-9D25-4CEE-A360-340A4D823955}"/>
                </a:ext>
              </a:extLst>
            </p:cNvPr>
            <p:cNvSpPr txBox="1"/>
            <p:nvPr/>
          </p:nvSpPr>
          <p:spPr>
            <a:xfrm>
              <a:off x="9518" y="4900"/>
              <a:ext cx="59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>
                  <a:solidFill>
                    <a:schemeClr val="bg1"/>
                  </a:solidFill>
                  <a:latin typeface="Times New Roman" panose="02020603050405020304" charset="0"/>
                  <a:cs typeface="Times New Roman" panose="02020603050405020304" charset="0"/>
                </a:rPr>
                <a:t>B</a:t>
              </a: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AF254A2C-68D8-49BE-9BFE-F8E44E4F2BC5}"/>
                </a:ext>
              </a:extLst>
            </p:cNvPr>
            <p:cNvSpPr txBox="1"/>
            <p:nvPr/>
          </p:nvSpPr>
          <p:spPr>
            <a:xfrm>
              <a:off x="4933" y="9328"/>
              <a:ext cx="59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>
                  <a:solidFill>
                    <a:schemeClr val="bg1"/>
                  </a:solidFill>
                  <a:latin typeface="Times New Roman" panose="02020603050405020304" charset="0"/>
                  <a:cs typeface="Times New Roman" panose="02020603050405020304" charset="0"/>
                </a:rPr>
                <a:t>C</a:t>
              </a: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2BA4E399-62F3-4F7A-9DB3-CC8622B20818}"/>
                </a:ext>
              </a:extLst>
            </p:cNvPr>
            <p:cNvSpPr txBox="1"/>
            <p:nvPr/>
          </p:nvSpPr>
          <p:spPr>
            <a:xfrm>
              <a:off x="9518" y="9390"/>
              <a:ext cx="59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>
                  <a:solidFill>
                    <a:schemeClr val="bg1"/>
                  </a:solidFill>
                  <a:latin typeface="Times New Roman" panose="02020603050405020304" charset="0"/>
                  <a:cs typeface="Times New Roman" panose="02020603050405020304" charset="0"/>
                </a:rPr>
                <a:t>D</a:t>
              </a:r>
            </a:p>
          </p:txBody>
        </p:sp>
      </p:grpSp>
      <p:sp>
        <p:nvSpPr>
          <p:cNvPr id="11" name="文本框 10">
            <a:extLst>
              <a:ext uri="{FF2B5EF4-FFF2-40B4-BE49-F238E27FC236}">
                <a16:creationId xmlns:a16="http://schemas.microsoft.com/office/drawing/2014/main" id="{F4EAF263-23BC-418A-9C08-922E90F14A86}"/>
              </a:ext>
            </a:extLst>
          </p:cNvPr>
          <p:cNvSpPr txBox="1"/>
          <p:nvPr/>
        </p:nvSpPr>
        <p:spPr>
          <a:xfrm>
            <a:off x="6785292" y="2880360"/>
            <a:ext cx="475043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Fig S5 Symptoms of PyRV1-infected </a:t>
            </a:r>
            <a:r>
              <a:rPr lang="en-US" altLang="zh-CN" sz="1200" i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P. </a:t>
            </a:r>
            <a:r>
              <a:rPr lang="en-US" altLang="zh-CN" sz="1200" i="1" dirty="0" err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polyphylla</a:t>
            </a:r>
            <a:r>
              <a:rPr lang="en-US" altLang="zh-CN" sz="1200" i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var. </a:t>
            </a:r>
            <a:r>
              <a:rPr lang="en-US" altLang="zh-CN" sz="1200" i="1" dirty="0" err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yunnanensis</a:t>
            </a:r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.</a:t>
            </a:r>
          </a:p>
          <a:p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A</a:t>
            </a:r>
            <a:r>
              <a:rPr lang="en-US" sz="12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.  Yellow and mottle symptoms on the leaves of No. 1 </a:t>
            </a:r>
            <a:r>
              <a:rPr lang="en-US" altLang="zh-CN" sz="1200" i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P. </a:t>
            </a:r>
            <a:r>
              <a:rPr lang="en-US" altLang="zh-CN" sz="1200" i="1" dirty="0" err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polyphylla</a:t>
            </a:r>
            <a:r>
              <a:rPr lang="en-US" altLang="zh-CN" sz="1200" i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var.</a:t>
            </a:r>
            <a:r>
              <a:rPr lang="en-US" altLang="zh-CN" sz="1200" i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r>
              <a:rPr lang="en-US" altLang="zh-CN" sz="1200" i="1" dirty="0" err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yunnanensis</a:t>
            </a:r>
            <a:r>
              <a:rPr lang="en-US" altLang="zh-CN" sz="1200" i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were </a:t>
            </a:r>
            <a:r>
              <a:rPr lang="en-US" sz="12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inoculated by PyRV1.  </a:t>
            </a:r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B. </a:t>
            </a:r>
            <a:r>
              <a:rPr lang="en-US" sz="12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Yellow and mottle symptoms on the leaves of No. 2 </a:t>
            </a:r>
            <a:r>
              <a:rPr lang="en-US" altLang="zh-CN" sz="1200" i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P. </a:t>
            </a:r>
            <a:r>
              <a:rPr lang="en-US" altLang="zh-CN" sz="1200" i="1" dirty="0" err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polyphylla</a:t>
            </a:r>
            <a:r>
              <a:rPr lang="en-US" altLang="zh-CN" sz="1200" i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var.</a:t>
            </a:r>
            <a:r>
              <a:rPr lang="en-US" altLang="zh-CN" sz="1200" i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r>
              <a:rPr lang="en-US" altLang="zh-CN" sz="1200" i="1" dirty="0" err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yunnanensis</a:t>
            </a:r>
            <a:r>
              <a:rPr lang="en-US" altLang="zh-CN" sz="1200" i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were </a:t>
            </a:r>
            <a:r>
              <a:rPr lang="en-US" sz="12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inoculated by PyRV1. C: Yellow and mottle symptoms on the leaves of No. 3 </a:t>
            </a:r>
            <a:r>
              <a:rPr lang="en-US" altLang="zh-CN" sz="1200" i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P. </a:t>
            </a:r>
            <a:r>
              <a:rPr lang="en-US" altLang="zh-CN" sz="1200" i="1" dirty="0" err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polyphylla</a:t>
            </a:r>
            <a:r>
              <a:rPr lang="en-US" altLang="zh-CN" sz="1200" i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var.</a:t>
            </a:r>
            <a:r>
              <a:rPr lang="en-US" altLang="zh-CN" sz="1200" i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r>
              <a:rPr lang="en-US" altLang="zh-CN" sz="1200" i="1" dirty="0" err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yunnanensis</a:t>
            </a:r>
            <a:r>
              <a:rPr lang="en-US" altLang="zh-CN" sz="1200" i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were </a:t>
            </a:r>
            <a:r>
              <a:rPr lang="en-US" sz="12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inoculated by PyRV1.</a:t>
            </a:r>
            <a:endParaRPr lang="en-US" altLang="zh-CN" sz="1200" dirty="0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  <p:extLst>
      <p:ext uri="{BB962C8B-B14F-4D97-AF65-F5344CB8AC3E}">
        <p14:creationId xmlns:p14="http://schemas.microsoft.com/office/powerpoint/2010/main" val="305612250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文本框 24"/>
          <p:cNvSpPr txBox="1"/>
          <p:nvPr/>
        </p:nvSpPr>
        <p:spPr>
          <a:xfrm>
            <a:off x="2580830" y="4666615"/>
            <a:ext cx="866543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Fig. S5. RT-PCR amplification of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of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P.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polyphylla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var.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yunnanensis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inoculated by PyRV1.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M: DNA Marker DL2000. Lane 1: Positive control. Lane 2-5: the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inoculated samples 1-4 at four weeks post inoculation.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Lane 6-9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：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the 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inoculated sample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 1-4 at eight weeks post inoculation.</a:t>
            </a:r>
          </a:p>
        </p:txBody>
      </p:sp>
      <p:grpSp>
        <p:nvGrpSpPr>
          <p:cNvPr id="3" name="组合 2"/>
          <p:cNvGrpSpPr/>
          <p:nvPr/>
        </p:nvGrpSpPr>
        <p:grpSpPr>
          <a:xfrm>
            <a:off x="3541527" y="2006353"/>
            <a:ext cx="5108945" cy="1665823"/>
            <a:chOff x="9349" y="2157"/>
            <a:chExt cx="4876" cy="2130"/>
          </a:xfrm>
        </p:grpSpPr>
        <p:grpSp>
          <p:nvGrpSpPr>
            <p:cNvPr id="33" name="组合 32"/>
            <p:cNvGrpSpPr/>
            <p:nvPr/>
          </p:nvGrpSpPr>
          <p:grpSpPr>
            <a:xfrm>
              <a:off x="9349" y="2157"/>
              <a:ext cx="4728" cy="2130"/>
              <a:chOff x="9655" y="3471"/>
              <a:chExt cx="4646" cy="1822"/>
            </a:xfrm>
          </p:grpSpPr>
          <p:pic>
            <p:nvPicPr>
              <p:cNvPr id="10" name="图片 9"/>
              <p:cNvPicPr>
                <a:picLocks noChangeAspect="1"/>
              </p:cNvPicPr>
              <p:nvPr/>
            </p:nvPicPr>
            <p:blipFill rotWithShape="1">
              <a:blip r:embed="rId2"/>
              <a:srcRect l="38135" t="44116" r="36600" b="44391"/>
              <a:stretch/>
            </p:blipFill>
            <p:spPr>
              <a:xfrm>
                <a:off x="10591" y="3980"/>
                <a:ext cx="3710" cy="1267"/>
              </a:xfrm>
              <a:prstGeom prst="rect">
                <a:avLst/>
              </a:prstGeom>
            </p:spPr>
          </p:pic>
          <p:grpSp>
            <p:nvGrpSpPr>
              <p:cNvPr id="16" name="组合 15"/>
              <p:cNvGrpSpPr/>
              <p:nvPr/>
            </p:nvGrpSpPr>
            <p:grpSpPr>
              <a:xfrm>
                <a:off x="9655" y="3471"/>
                <a:ext cx="4538" cy="1822"/>
                <a:chOff x="895" y="3225"/>
                <a:chExt cx="4538" cy="1822"/>
              </a:xfrm>
            </p:grpSpPr>
            <p:sp>
              <p:nvSpPr>
                <p:cNvPr id="19" name="文本框 18"/>
                <p:cNvSpPr txBox="1"/>
                <p:nvPr/>
              </p:nvSpPr>
              <p:spPr>
                <a:xfrm>
                  <a:off x="1895" y="3225"/>
                  <a:ext cx="3538" cy="40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dist"/>
                  <a:r>
                    <a:rPr lang="en-US" altLang="zh-CN" dirty="0"/>
                    <a:t> </a:t>
                  </a:r>
                  <a:r>
                    <a:rPr lang="en-US" altLang="zh-CN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  1    2   3    4   5    6    7    8   9   </a:t>
                  </a:r>
                </a:p>
              </p:txBody>
            </p:sp>
            <p:sp>
              <p:nvSpPr>
                <p:cNvPr id="20" name="文本框 19"/>
                <p:cNvSpPr txBox="1"/>
                <p:nvPr/>
              </p:nvSpPr>
              <p:spPr>
                <a:xfrm>
                  <a:off x="895" y="3788"/>
                  <a:ext cx="1090" cy="37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000bp</a:t>
                  </a:r>
                </a:p>
              </p:txBody>
            </p:sp>
            <p:sp>
              <p:nvSpPr>
                <p:cNvPr id="30" name="文本框 29"/>
                <p:cNvSpPr txBox="1"/>
                <p:nvPr/>
              </p:nvSpPr>
              <p:spPr>
                <a:xfrm>
                  <a:off x="1021" y="4676"/>
                  <a:ext cx="1090" cy="37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12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00bp</a:t>
                  </a:r>
                </a:p>
              </p:txBody>
            </p:sp>
            <p:sp>
              <p:nvSpPr>
                <p:cNvPr id="31" name="文本框 30"/>
                <p:cNvSpPr txBox="1"/>
                <p:nvPr/>
              </p:nvSpPr>
              <p:spPr>
                <a:xfrm>
                  <a:off x="1021" y="4456"/>
                  <a:ext cx="1090" cy="37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12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50bp</a:t>
                  </a:r>
                </a:p>
              </p:txBody>
            </p:sp>
            <p:sp>
              <p:nvSpPr>
                <p:cNvPr id="32" name="文本框 31"/>
                <p:cNvSpPr txBox="1"/>
                <p:nvPr/>
              </p:nvSpPr>
              <p:spPr>
                <a:xfrm>
                  <a:off x="898" y="4241"/>
                  <a:ext cx="1090" cy="37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l"/>
                  <a:r>
                    <a:rPr lang="en-US" altLang="zh-CN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0bp</a:t>
                  </a:r>
                </a:p>
              </p:txBody>
            </p:sp>
          </p:grpSp>
        </p:grpSp>
        <p:cxnSp>
          <p:nvCxnSpPr>
            <p:cNvPr id="2" name="直接连接符 1"/>
            <p:cNvCxnSpPr/>
            <p:nvPr/>
          </p:nvCxnSpPr>
          <p:spPr>
            <a:xfrm flipV="1">
              <a:off x="13903" y="3389"/>
              <a:ext cx="322" cy="253"/>
            </a:xfrm>
            <a:prstGeom prst="line">
              <a:avLst/>
            </a:prstGeom>
            <a:ln w="28575">
              <a:solidFill>
                <a:srgbClr val="00FF00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Yzc1MzA0ZDQzN2M2MTFjMDc5MTU3NjIwMTVjNTNlZjAifQ=="/>
  <p:tag name="KSO_WPP_MARK_KEY" val="01c13d75-ae07-4b2c-a4d1-5da594ef27f1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565</Words>
  <Application>Microsoft Office PowerPoint</Application>
  <PresentationFormat>宽屏</PresentationFormat>
  <Paragraphs>99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董家红</dc:creator>
  <cp:lastModifiedBy>K78385</cp:lastModifiedBy>
  <cp:revision>195</cp:revision>
  <dcterms:created xsi:type="dcterms:W3CDTF">2021-09-24T05:56:00Z</dcterms:created>
  <dcterms:modified xsi:type="dcterms:W3CDTF">2022-11-11T07:12:2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65D275956A1B48E7A8B881AD0D79ACA4</vt:lpwstr>
  </property>
  <property fmtid="{D5CDD505-2E9C-101B-9397-08002B2CF9AE}" pid="3" name="KSOProductBuildVer">
    <vt:lpwstr>2052-11.1.0.12763</vt:lpwstr>
  </property>
</Properties>
</file>